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90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E" lastIdx="5" clrIdx="0">
    <p:extLst>
      <p:ext uri="{19B8F6BF-5375-455C-9EA6-DF929625EA0E}">
        <p15:presenceInfo xmlns:p15="http://schemas.microsoft.com/office/powerpoint/2012/main" userId="ELIS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000"/>
    <a:srgbClr val="EEEAE1"/>
    <a:srgbClr val="F7F7F7"/>
    <a:srgbClr val="00FF00"/>
    <a:srgbClr val="B686E6"/>
    <a:srgbClr val="BC5D1C"/>
    <a:srgbClr val="9AC97B"/>
    <a:srgbClr val="335AA1"/>
    <a:srgbClr val="70AD47"/>
    <a:srgbClr val="997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26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1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36C90-24BC-405A-9A12-BA1DD00114A9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67A84-EC68-40BB-9EDF-C0B77FBE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92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2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7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33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6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2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3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3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8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11" Type="http://schemas.openxmlformats.org/officeDocument/2006/relationships/image" Target="../media/image10.tiff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F04CE73A-173E-0E0B-C2A1-2F17CB3471BB}"/>
              </a:ext>
            </a:extLst>
          </p:cNvPr>
          <p:cNvGrpSpPr>
            <a:grpSpLocks noChangeAspect="1"/>
          </p:cNvGrpSpPr>
          <p:nvPr/>
        </p:nvGrpSpPr>
        <p:grpSpPr>
          <a:xfrm>
            <a:off x="601543" y="0"/>
            <a:ext cx="5654912" cy="8424000"/>
            <a:chOff x="119074" y="3148"/>
            <a:chExt cx="6194832" cy="9228316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8F912BB0-E856-47A8-AB5D-436FE7FA1B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875982" y="712902"/>
              <a:ext cx="2692400" cy="2011563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59E779AD-7C5C-4FF1-9D70-420C26F6A61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-218382" y="712901"/>
              <a:ext cx="2692401" cy="2011563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8FD52891-A8E1-498A-8051-8D0DB042F6E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31281" y="712900"/>
              <a:ext cx="2692401" cy="2011564"/>
            </a:xfrm>
            <a:prstGeom prst="rect">
              <a:avLst/>
            </a:prstGeom>
          </p:spPr>
        </p:pic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B71B4F13-B093-448C-AD66-F032E2EC845C}"/>
                </a:ext>
              </a:extLst>
            </p:cNvPr>
            <p:cNvSpPr txBox="1"/>
            <p:nvPr/>
          </p:nvSpPr>
          <p:spPr>
            <a:xfrm>
              <a:off x="238818" y="3064883"/>
              <a:ext cx="1905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/>
                <a:t>b</a:t>
              </a:r>
            </a:p>
          </p:txBody>
        </p:sp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553A10D7-CC8E-4E96-AF5F-552065D5711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-221345" y="3774635"/>
              <a:ext cx="2692401" cy="2011564"/>
            </a:xfrm>
            <a:prstGeom prst="rect">
              <a:avLst/>
            </a:prstGeom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34A3CEAF-C32D-4374-84A6-D848B91C512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7518" y="4480555"/>
              <a:ext cx="2964" cy="2214"/>
            </a:xfrm>
            <a:prstGeom prst="rect">
              <a:avLst/>
            </a:prstGeom>
          </p:spPr>
        </p:pic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801016A9-ECFE-48FC-BA0E-62B9A301B1A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3910621" y="3765398"/>
              <a:ext cx="2688437" cy="2026074"/>
            </a:xfrm>
            <a:prstGeom prst="rect">
              <a:avLst/>
            </a:prstGeom>
          </p:spPr>
        </p:pic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41C0D4CD-A58B-48DF-A930-32FA9B764DD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 flipH="1">
              <a:off x="1842263" y="3805946"/>
              <a:ext cx="2692402" cy="1989599"/>
            </a:xfrm>
            <a:prstGeom prst="rect">
              <a:avLst/>
            </a:prstGeom>
          </p:spPr>
        </p:pic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BFA5D21A-1DE5-47C5-9E0C-7627FCA734F3}"/>
                </a:ext>
              </a:extLst>
            </p:cNvPr>
            <p:cNvSpPr txBox="1"/>
            <p:nvPr/>
          </p:nvSpPr>
          <p:spPr>
            <a:xfrm>
              <a:off x="225638" y="6170340"/>
              <a:ext cx="1905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/>
                <a:t>c</a:t>
              </a:r>
            </a:p>
          </p:txBody>
        </p:sp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F5ABA55C-FC30-4472-B2C5-3F3158D1219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98285" y="6879481"/>
              <a:ext cx="2692402" cy="2011564"/>
            </a:xfrm>
            <a:prstGeom prst="rect">
              <a:avLst/>
            </a:prstGeom>
          </p:spPr>
        </p:pic>
        <p:pic>
          <p:nvPicPr>
            <p:cNvPr id="24" name="Image 23">
              <a:extLst>
                <a:ext uri="{FF2B5EF4-FFF2-40B4-BE49-F238E27FC236}">
                  <a16:creationId xmlns:a16="http://schemas.microsoft.com/office/drawing/2014/main" id="{486D51C4-1108-41C4-A461-C6234006CC6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-186641" y="6879819"/>
              <a:ext cx="2676027" cy="1999330"/>
            </a:xfrm>
            <a:prstGeom prst="rect">
              <a:avLst/>
            </a:prstGeom>
          </p:spPr>
        </p:pic>
        <p:pic>
          <p:nvPicPr>
            <p:cNvPr id="26" name="Image 25">
              <a:extLst>
                <a:ext uri="{FF2B5EF4-FFF2-40B4-BE49-F238E27FC236}">
                  <a16:creationId xmlns:a16="http://schemas.microsoft.com/office/drawing/2014/main" id="{2421F4AE-2D91-4D40-8157-F955DA76224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965384" y="6868973"/>
              <a:ext cx="2688440" cy="2008605"/>
            </a:xfrm>
            <a:prstGeom prst="rect">
              <a:avLst/>
            </a:prstGeom>
          </p:spPr>
        </p:pic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883547DA-0586-25C2-C899-F5FAE88616E7}"/>
                </a:ext>
              </a:extLst>
            </p:cNvPr>
            <p:cNvSpPr txBox="1"/>
            <p:nvPr/>
          </p:nvSpPr>
          <p:spPr>
            <a:xfrm>
              <a:off x="225638" y="3148"/>
              <a:ext cx="1905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/>
                <a:t>a</a:t>
              </a:r>
            </a:p>
          </p:txBody>
        </p:sp>
      </p:grpSp>
      <p:sp>
        <p:nvSpPr>
          <p:cNvPr id="14" name="ZoneTexte 13">
            <a:extLst>
              <a:ext uri="{FF2B5EF4-FFF2-40B4-BE49-F238E27FC236}">
                <a16:creationId xmlns:a16="http://schemas.microsoft.com/office/drawing/2014/main" id="{4B003806-D1DB-6BEE-8FDB-EA525A77857E}"/>
              </a:ext>
            </a:extLst>
          </p:cNvPr>
          <p:cNvSpPr txBox="1"/>
          <p:nvPr/>
        </p:nvSpPr>
        <p:spPr>
          <a:xfrm>
            <a:off x="0" y="8745650"/>
            <a:ext cx="6857999" cy="11592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4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2, Fig. S2.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sualisation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maculans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mb)-GFP and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biglobosa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bb)-RFP mycelia during growth of mixed species on agar medium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algn="just">
              <a:spcAft>
                <a:spcPts val="4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inoculum mix consisted of a mix of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ores 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mb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spension +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ores 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bb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spension. Pictures were taken after four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 b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seven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days of growth on MMII agar medium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 c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V-8 agar medium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For each panel : left picture, bright field; center picture : GFP-expressing Lmb; bottom picture, RFP- expressing Lbb. 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49732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</TotalTime>
  <Words>121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Windows</dc:creator>
  <cp:lastModifiedBy>Graham Bell</cp:lastModifiedBy>
  <cp:revision>780</cp:revision>
  <dcterms:created xsi:type="dcterms:W3CDTF">2020-02-06T09:05:41Z</dcterms:created>
  <dcterms:modified xsi:type="dcterms:W3CDTF">2023-10-05T10:44:46Z</dcterms:modified>
</cp:coreProperties>
</file>